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13.jpeg" ContentType="image/jpe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12.jpeg" ContentType="image/jpe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7E701F-E182-43C2-85E4-4AAB02C59DF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93B784-9BE5-476D-BC45-4FE7EDB81E8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CB222E-8CDF-4C9A-9CE0-0E22B47852D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E9A020-7771-4366-B9E1-0EDDF202823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7EFDF5-0FC9-4351-A717-BACF1DB7D93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E71757-BD44-4A04-A71F-F120ED1290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C26BF4-EDF6-475D-A012-E9FD5700392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7F035D-3953-4EB4-87D4-39D78D60036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DAE58B-B089-4A45-A3E0-E016CB912F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BAC696-166D-4EF4-BEF2-895871571C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9E1DCA-B8DC-414E-AA31-DFF5A73249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888BF7-91CC-40F1-9943-659E0FD7AA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ACE5F90-577A-476A-A398-53CDE298049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2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3.jpeg"/><Relationship Id="rId2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3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3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3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3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2.jpeg"/><Relationship Id="rId2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366200" y="0"/>
            <a:ext cx="233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(14,25,28) – Lipniacki’s mode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277640" y="6324480"/>
            <a:ext cx="64886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ure 1S. Three steps of simplification of the Lipniacki’s model. Pink nodes are intermediat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pecies in the reduction, blue ones are terminal specie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4561920" y="0"/>
            <a:ext cx="3998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(8,12,19) – After reduction of the cytoplasmic signal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447480" y="3124080"/>
            <a:ext cx="4239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(6,10,15) – After reduction of the nuclear Ik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Nf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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 bind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" descr=""/>
          <p:cNvPicPr/>
          <p:nvPr/>
        </p:nvPicPr>
        <p:blipFill>
          <a:blip r:embed="rId1"/>
          <a:stretch/>
        </p:blipFill>
        <p:spPr>
          <a:xfrm>
            <a:off x="4876920" y="3352680"/>
            <a:ext cx="3290760" cy="2743200"/>
          </a:xfrm>
          <a:prstGeom prst="rect">
            <a:avLst/>
          </a:prstGeom>
          <a:ln w="0">
            <a:noFill/>
          </a:ln>
        </p:spPr>
      </p:pic>
      <p:sp>
        <p:nvSpPr>
          <p:cNvPr id="46" name=""/>
          <p:cNvSpPr/>
          <p:nvPr/>
        </p:nvSpPr>
        <p:spPr>
          <a:xfrm>
            <a:off x="4809240" y="3125880"/>
            <a:ext cx="4161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(5,8,12) – After reduction of the A20 transcription modul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" descr=""/>
          <p:cNvPicPr/>
          <p:nvPr/>
        </p:nvPicPr>
        <p:blipFill>
          <a:blip r:embed="rId2"/>
          <a:stretch/>
        </p:blipFill>
        <p:spPr>
          <a:xfrm>
            <a:off x="893880" y="307800"/>
            <a:ext cx="3290760" cy="2743200"/>
          </a:xfrm>
          <a:prstGeom prst="rect">
            <a:avLst/>
          </a:prstGeom>
          <a:ln w="0">
            <a:noFill/>
          </a:ln>
        </p:spPr>
      </p:pic>
      <p:pic>
        <p:nvPicPr>
          <p:cNvPr id="48" name="" descr=""/>
          <p:cNvPicPr/>
          <p:nvPr/>
        </p:nvPicPr>
        <p:blipFill>
          <a:blip r:embed="rId3"/>
          <a:stretch/>
        </p:blipFill>
        <p:spPr>
          <a:xfrm>
            <a:off x="4648320" y="316080"/>
            <a:ext cx="3290760" cy="2743200"/>
          </a:xfrm>
          <a:prstGeom prst="rect">
            <a:avLst/>
          </a:prstGeom>
          <a:ln w="0">
            <a:noFill/>
          </a:ln>
        </p:spPr>
      </p:pic>
      <p:pic>
        <p:nvPicPr>
          <p:cNvPr id="49" name="" descr=""/>
          <p:cNvPicPr/>
          <p:nvPr/>
        </p:nvPicPr>
        <p:blipFill>
          <a:blip r:embed="rId4"/>
          <a:stretch/>
        </p:blipFill>
        <p:spPr>
          <a:xfrm>
            <a:off x="1066680" y="3352680"/>
            <a:ext cx="3291120" cy="2743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"/>
          <p:cNvSpPr/>
          <p:nvPr/>
        </p:nvSpPr>
        <p:spPr>
          <a:xfrm>
            <a:off x="1122120" y="5410080"/>
            <a:ext cx="713484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ure 3S2. Another view on the truly non-linear reaction modes.  For 17 non-monomolecular reaction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of the most complex model M(39,65,90), ratios of reactants concentrations are shown. One can defin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ruly non-linear periods for the reaction if its reactant ratio is in the [0.1,10] interva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Otherwise, the reactant concentrations are separated by more than one order of magnitude and th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eaction rate can be approximated by a pseudo-monomolecular on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4" name="" descr=""/>
          <p:cNvPicPr/>
          <p:nvPr/>
        </p:nvPicPr>
        <p:blipFill>
          <a:blip r:embed="rId1"/>
          <a:srcRect l="9271" t="5391" r="8610" b="3592"/>
          <a:stretch/>
        </p:blipFill>
        <p:spPr>
          <a:xfrm>
            <a:off x="0" y="0"/>
            <a:ext cx="8686800" cy="5322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" descr=""/>
          <p:cNvPicPr/>
          <p:nvPr/>
        </p:nvPicPr>
        <p:blipFill>
          <a:blip r:embed="rId1"/>
          <a:stretch/>
        </p:blipFill>
        <p:spPr>
          <a:xfrm>
            <a:off x="306360" y="77760"/>
            <a:ext cx="5484960" cy="5484960"/>
          </a:xfrm>
          <a:prstGeom prst="rect">
            <a:avLst/>
          </a:prstGeom>
          <a:ln w="0">
            <a:noFill/>
          </a:ln>
        </p:spPr>
      </p:pic>
      <p:sp>
        <p:nvSpPr>
          <p:cNvPr id="51" name=""/>
          <p:cNvSpPr/>
          <p:nvPr/>
        </p:nvSpPr>
        <p:spPr>
          <a:xfrm>
            <a:off x="5625720" y="1027080"/>
            <a:ext cx="1410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(39,65,90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971360" y="6019920"/>
            <a:ext cx="5645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ure 2S1. Structure of the most complex model M(39,65,90) for NfkB signall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"/>
          <p:cNvSpPr/>
          <p:nvPr/>
        </p:nvSpPr>
        <p:spPr>
          <a:xfrm>
            <a:off x="5793840" y="990720"/>
            <a:ext cx="1410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(34,60,82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350360" y="6019920"/>
            <a:ext cx="695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ure 2S2. Structure of the model for NfkB signalling after reduction of the p65 transcription modul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" descr=""/>
          <p:cNvPicPr/>
          <p:nvPr/>
        </p:nvPicPr>
        <p:blipFill>
          <a:blip r:embed="rId1"/>
          <a:stretch/>
        </p:blipFill>
        <p:spPr>
          <a:xfrm>
            <a:off x="306360" y="77760"/>
            <a:ext cx="5484960" cy="5484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"/>
          <p:cNvSpPr/>
          <p:nvPr/>
        </p:nvSpPr>
        <p:spPr>
          <a:xfrm>
            <a:off x="5793840" y="990720"/>
            <a:ext cx="1410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(24,45,62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1350360" y="6019920"/>
            <a:ext cx="695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ure 2S3. Structure of the model for NfkB signalling after reduction of the p50 transcription modul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" descr=""/>
          <p:cNvPicPr/>
          <p:nvPr/>
        </p:nvPicPr>
        <p:blipFill>
          <a:blip r:embed="rId1"/>
          <a:stretch/>
        </p:blipFill>
        <p:spPr>
          <a:xfrm>
            <a:off x="304920" y="76320"/>
            <a:ext cx="5484600" cy="5484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"/>
          <p:cNvSpPr/>
          <p:nvPr/>
        </p:nvSpPr>
        <p:spPr>
          <a:xfrm>
            <a:off x="5793840" y="990720"/>
            <a:ext cx="1410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(16,34,46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1317600" y="6018120"/>
            <a:ext cx="7028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ure 2S4. Structure of the model for NfkB signalling after reduction of the I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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transcription modul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" descr=""/>
          <p:cNvPicPr/>
          <p:nvPr/>
        </p:nvPicPr>
        <p:blipFill>
          <a:blip r:embed="rId1"/>
          <a:stretch/>
        </p:blipFill>
        <p:spPr>
          <a:xfrm>
            <a:off x="304920" y="76320"/>
            <a:ext cx="5484600" cy="5484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"/>
          <p:cNvSpPr/>
          <p:nvPr/>
        </p:nvSpPr>
        <p:spPr>
          <a:xfrm>
            <a:off x="5793840" y="990720"/>
            <a:ext cx="1410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(14,30,41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1656720" y="6019920"/>
            <a:ext cx="638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ure 2S5. Structure of the model for NfkB signalling after reduction of the p50-p65 bind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4" name="" descr=""/>
          <p:cNvPicPr/>
          <p:nvPr/>
        </p:nvPicPr>
        <p:blipFill>
          <a:blip r:embed="rId1"/>
          <a:stretch/>
        </p:blipFill>
        <p:spPr>
          <a:xfrm>
            <a:off x="306360" y="77760"/>
            <a:ext cx="5484960" cy="5484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"/>
          <p:cNvSpPr/>
          <p:nvPr/>
        </p:nvSpPr>
        <p:spPr>
          <a:xfrm>
            <a:off x="5793840" y="990720"/>
            <a:ext cx="1410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(14,25,33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1391760" y="6018120"/>
            <a:ext cx="6965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ure 2S6. Structure of the model for NfkB signalling after introduction of the Nf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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 conservation law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" name="" descr=""/>
          <p:cNvPicPr/>
          <p:nvPr/>
        </p:nvPicPr>
        <p:blipFill>
          <a:blip r:embed="rId1"/>
          <a:stretch/>
        </p:blipFill>
        <p:spPr>
          <a:xfrm>
            <a:off x="306360" y="77760"/>
            <a:ext cx="5484960" cy="5484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"/>
          <p:cNvSpPr/>
          <p:nvPr/>
        </p:nvSpPr>
        <p:spPr>
          <a:xfrm>
            <a:off x="5793840" y="990720"/>
            <a:ext cx="1410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(14,25,29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1605240" y="6018120"/>
            <a:ext cx="6584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ure 2S7. Structure of the model for NfkB signalling after simplifying the I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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production rat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0" name="" descr=""/>
          <p:cNvPicPr/>
          <p:nvPr/>
        </p:nvPicPr>
        <p:blipFill>
          <a:blip r:embed="rId1"/>
          <a:stretch/>
        </p:blipFill>
        <p:spPr>
          <a:xfrm>
            <a:off x="306360" y="77760"/>
            <a:ext cx="5484960" cy="5484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" name="" descr=""/>
          <p:cNvPicPr/>
          <p:nvPr/>
        </p:nvPicPr>
        <p:blipFill>
          <a:blip r:embed="rId1"/>
          <a:srcRect l="10092" t="4976" r="9174" b="7087"/>
          <a:stretch/>
        </p:blipFill>
        <p:spPr>
          <a:xfrm>
            <a:off x="685800" y="152280"/>
            <a:ext cx="7848720" cy="4727520"/>
          </a:xfrm>
          <a:prstGeom prst="rect">
            <a:avLst/>
          </a:prstGeom>
          <a:ln w="0">
            <a:noFill/>
          </a:ln>
        </p:spPr>
      </p:pic>
      <p:sp>
        <p:nvSpPr>
          <p:cNvPr id="72" name=""/>
          <p:cNvSpPr/>
          <p:nvPr/>
        </p:nvSpPr>
        <p:spPr>
          <a:xfrm>
            <a:off x="1129320" y="4876920"/>
            <a:ext cx="702504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ure 3S1. Estimating number of non-linear reactions that function in the true ‘non-linear’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(not pseudo-monomolecular) mode. The most complex model M(39,65,90) formally contain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7 non-linear reactions (complex bindings, catalyses). However, only in 4 of them the reactants hav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mparable concentration levels in some periods of time. These reactions are listed at top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he time periods of ‘non-linearity’ (when reaction reactants have comparable concentrations)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re marked by rectangles of the color corresponding to the reaction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0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4-06T09:53:11Z</dcterms:created>
  <dc:creator>Andrei Zinovyev</dc:creator>
  <dc:description/>
  <dc:language>en-US</dc:language>
  <cp:lastModifiedBy>Andrei Zinovyev</cp:lastModifiedBy>
  <dcterms:modified xsi:type="dcterms:W3CDTF">2008-04-06T23:16:36Z</dcterms:modified>
  <cp:revision>35</cp:revision>
  <dc:subject/>
  <dc:title>Diapositive 1</dc:title>
</cp:coreProperties>
</file>